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660596-A8B6-44FF-8930-1CB46CDA139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6B4B72-B928-45DF-8A89-8680C33BA06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276ED4-C36B-40C5-A664-C37EA6FDC0F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57556D-D5F2-4660-B7AE-CB66854745A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590DA1-9ED2-46E0-9E20-34A3B746F0E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DAA4F2-819C-49BA-85EB-2B97DB533D0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731EE3-12AC-42A1-9A2D-EBB3A1D3361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E75806-CEEE-4D03-8179-0E04CB7C5D3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6AA21E-2FC6-4B80-8CB7-081FCBE8095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E85A87-62B6-4635-9A78-1432AAD6457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942826-C3D4-446A-98C1-3190B9F8A7D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4A5A51-5DBC-42E7-A49F-FC62DF9BBF6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B603688-5617-46FA-B651-60F3EF2BFBDF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Observed gas-phase HOMs and their volatility distribution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Content Placeholder 3" descr=""/>
          <p:cNvPicPr/>
          <p:nvPr/>
        </p:nvPicPr>
        <p:blipFill>
          <a:blip r:embed="rId1"/>
          <a:stretch/>
        </p:blipFill>
        <p:spPr>
          <a:xfrm>
            <a:off x="2971800" y="1182600"/>
            <a:ext cx="3200400" cy="452304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5" descr="D:\PPT_Out\nature-logo.jpg"/>
          <p:cNvPicPr/>
          <p:nvPr/>
        </p:nvPicPr>
        <p:blipFill>
          <a:blip r:embed="rId2"/>
          <a:stretch/>
        </p:blipFill>
        <p:spPr>
          <a:xfrm>
            <a:off x="6985080" y="6222960"/>
            <a:ext cx="1333440" cy="279360"/>
          </a:xfrm>
          <a:prstGeom prst="rect">
            <a:avLst/>
          </a:prstGeom>
          <a:ln w="0">
            <a:noFill/>
          </a:ln>
        </p:spPr>
      </p:pic>
      <p:sp>
        <p:nvSpPr>
          <p:cNvPr id="44" name="Title 1"/>
          <p:cNvSpPr/>
          <p:nvPr/>
        </p:nvSpPr>
        <p:spPr>
          <a:xfrm>
            <a:off x="444600" y="5851440"/>
            <a:ext cx="822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J Tröstl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 et al. Nature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33,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527–531 (2016) doi:10.1038/nature1827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5-18T09:41:02Z</dcterms:created>
  <dc:creator>ravikumar.n</dc:creator>
  <dc:description/>
  <dc:language>en-US</dc:language>
  <cp:lastModifiedBy>R.Vijitha</cp:lastModifiedBy>
  <dcterms:modified xsi:type="dcterms:W3CDTF">2016-05-18T09:42:52Z</dcterms:modified>
  <cp:revision>2</cp:revision>
  <dc:subject/>
  <dc:title>Observed gas-phase HOMs and their volatility distribution</dc:title>
</cp:coreProperties>
</file>